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1148000" cy="4114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9041A3-3B96-4CAB-B835-47F55B759A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057400" y="9600840"/>
            <a:ext cx="370332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057400" y="23784840"/>
            <a:ext cx="370332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193EF1-8E29-4B4B-A4BF-82A9ACB2A0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057400" y="9600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1033360" y="9600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057400" y="23784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1033360" y="23784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D1C13A-1123-4A3F-BE29-8028E94B64D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057400" y="9600840"/>
            <a:ext cx="1192428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4578200" y="9600840"/>
            <a:ext cx="1192428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7099000" y="9600840"/>
            <a:ext cx="1192428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057400" y="23784840"/>
            <a:ext cx="1192428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4578200" y="23784840"/>
            <a:ext cx="1192428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7099000" y="23784840"/>
            <a:ext cx="1192428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16DE1E-2461-4A93-A92B-80C5F548875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057400" y="9600840"/>
            <a:ext cx="37033200" cy="27155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099"/>
              </a:spcBef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A2F2AC-EE36-4E87-A546-ABEB545A96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057400" y="9600840"/>
            <a:ext cx="37033200" cy="2715588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5C6498-ABD1-47D7-BFDF-063A2A9A95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057400" y="9600840"/>
            <a:ext cx="18072000" cy="2715588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1033360" y="9600840"/>
            <a:ext cx="18072000" cy="2715588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571D89-A632-4B44-A692-4B6537FC8F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139813-290B-493D-BAE4-A5A9B95CEB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057400" y="1647720"/>
            <a:ext cx="37033200" cy="3179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099"/>
              </a:spcBef>
              <a:tabLst>
                <a:tab algn="l" pos="0"/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20A5A7-4F8A-4642-9144-DC422AC250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057400" y="9600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1033360" y="9600840"/>
            <a:ext cx="18072000" cy="2715588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057400" y="23784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1D5119-0F9F-4939-B362-19F17D5B35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057400" y="9600840"/>
            <a:ext cx="18072000" cy="2715588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1033360" y="9600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1033360" y="23784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171D2C-983E-4D09-8DBD-1EB2F0C3A5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057400" y="9600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1033360" y="9600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057400" y="23784840"/>
            <a:ext cx="370332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110622-2EF0-445E-9871-EBC32B90DC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r>
              <a:rPr b="0" lang="en-US" sz="227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057400" y="9600840"/>
            <a:ext cx="37033200" cy="2715588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marL="1762200" indent="-1762200">
              <a:spcBef>
                <a:spcPts val="4099"/>
              </a:spcBef>
              <a:buClr>
                <a:srgbClr val="000000"/>
              </a:buClr>
              <a:buFont typeface="Arial"/>
              <a:buChar char="•"/>
              <a:tabLst>
                <a:tab algn="l" pos="4702320"/>
                <a:tab algn="l" pos="9404280"/>
              </a:tabLst>
            </a:pPr>
            <a:r>
              <a:rPr b="0" lang="en-US" sz="16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  <a:p>
            <a:pPr lvl="1" marL="3819600" indent="-1468440">
              <a:spcBef>
                <a:spcPts val="4099"/>
              </a:spcBef>
              <a:buClr>
                <a:srgbClr val="000000"/>
              </a:buClr>
              <a:buFont typeface="Arial"/>
              <a:buChar char="–"/>
              <a:tabLst>
                <a:tab algn="l" pos="4702320"/>
                <a:tab algn="l" pos="9404280"/>
              </a:tabLst>
            </a:pPr>
            <a:r>
              <a:rPr b="0" lang="en-US" sz="16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  <a:p>
            <a:pPr lvl="2" marL="5877000" indent="-1174680">
              <a:spcBef>
                <a:spcPts val="4099"/>
              </a:spcBef>
              <a:buClr>
                <a:srgbClr val="000000"/>
              </a:buClr>
              <a:buFont typeface="Arial"/>
              <a:buChar char="•"/>
              <a:tabLst>
                <a:tab algn="l" pos="4702320"/>
                <a:tab algn="l" pos="9404280"/>
              </a:tabLst>
            </a:pPr>
            <a:r>
              <a:rPr b="0" lang="en-US" sz="16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  <a:p>
            <a:pPr lvl="3" marL="8228160" indent="-1175040">
              <a:spcBef>
                <a:spcPts val="4099"/>
              </a:spcBef>
              <a:buClr>
                <a:srgbClr val="000000"/>
              </a:buClr>
              <a:buFont typeface="Arial"/>
              <a:buChar char="–"/>
              <a:tabLst>
                <a:tab algn="l" pos="4702320"/>
                <a:tab algn="l" pos="9404280"/>
              </a:tabLst>
            </a:pPr>
            <a:r>
              <a:rPr b="0" lang="en-US" sz="16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  <a:p>
            <a:pPr lvl="4" marL="10580760" indent="-1174680">
              <a:spcBef>
                <a:spcPts val="4099"/>
              </a:spcBef>
              <a:buClr>
                <a:srgbClr val="000000"/>
              </a:buClr>
              <a:buFont typeface="Arial"/>
              <a:buChar char="»"/>
              <a:tabLst>
                <a:tab algn="l" pos="4702320"/>
                <a:tab algn="l" pos="9404280"/>
              </a:tabLst>
            </a:pPr>
            <a:r>
              <a:rPr b="0" lang="en-US" sz="16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  <a:p>
            <a:pPr lvl="5" marL="10580760" indent="-1174680">
              <a:spcBef>
                <a:spcPts val="4099"/>
              </a:spcBef>
              <a:buClr>
                <a:srgbClr val="000000"/>
              </a:buClr>
              <a:buFont typeface="Arial"/>
              <a:buChar char="»"/>
              <a:tabLst>
                <a:tab algn="l" pos="4702320"/>
                <a:tab algn="l" pos="9404280"/>
              </a:tabLst>
            </a:pPr>
            <a:r>
              <a:rPr b="0" lang="en-US" sz="16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  <a:p>
            <a:pPr lvl="6" marL="10580760" indent="-1174680">
              <a:spcBef>
                <a:spcPts val="4099"/>
              </a:spcBef>
              <a:buClr>
                <a:srgbClr val="000000"/>
              </a:buClr>
              <a:buFont typeface="Arial"/>
              <a:buChar char="»"/>
              <a:tabLst>
                <a:tab algn="l" pos="4702320"/>
                <a:tab algn="l" pos="9404280"/>
              </a:tabLst>
            </a:pPr>
            <a:r>
              <a:rPr b="0" lang="en-US" sz="16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057400" y="38138040"/>
            <a:ext cx="9601200" cy="21909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lstStyle>
            <a:lvl1pPr indent="0">
              <a:buNone/>
              <a:tabLst>
                <a:tab algn="l" pos="0"/>
                <a:tab algn="l" pos="4702320"/>
                <a:tab algn="l" pos="9404280"/>
              </a:tabLst>
              <a:defRPr b="0" lang="en-US" sz="6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702320"/>
                <a:tab algn="l" pos="9404280"/>
              </a:tabLst>
            </a:pPr>
            <a:r>
              <a:rPr b="0" lang="en-US" sz="61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6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4058720" y="38138040"/>
            <a:ext cx="13030200" cy="21909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9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9489400" y="38138040"/>
            <a:ext cx="9601200" cy="21909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lstStyle>
            <a:lvl1pPr indent="0" algn="r">
              <a:buNone/>
              <a:tabLst>
                <a:tab algn="l" pos="0"/>
                <a:tab algn="l" pos="4702320"/>
                <a:tab algn="l" pos="9404280"/>
              </a:tabLst>
              <a:defRPr b="0" lang="en-US" sz="6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702320"/>
                <a:tab algn="l" pos="9404280"/>
              </a:tabLst>
            </a:pPr>
            <a:fld id="{2FDE3D6C-4514-4FAF-BD02-DC1A8867C137}" type="slidenum">
              <a:rPr b="0" lang="en-US" sz="61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6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9"/>
          <p:cNvGrpSpPr/>
          <p:nvPr/>
        </p:nvGrpSpPr>
        <p:grpSpPr>
          <a:xfrm>
            <a:off x="304920" y="1905120"/>
            <a:ext cx="40114440" cy="40861800"/>
            <a:chOff x="304920" y="1905120"/>
            <a:chExt cx="40114440" cy="40861800"/>
          </a:xfrm>
        </p:grpSpPr>
        <p:pic>
          <p:nvPicPr>
            <p:cNvPr id="42" name="Picture 6" descr="fig 2.TIF"/>
            <p:cNvPicPr/>
            <p:nvPr/>
          </p:nvPicPr>
          <p:blipFill>
            <a:blip r:embed="rId1"/>
            <a:stretch/>
          </p:blipFill>
          <p:spPr>
            <a:xfrm>
              <a:off x="304920" y="1905120"/>
              <a:ext cx="40114440" cy="32986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Box 8"/>
            <p:cNvSpPr/>
            <p:nvPr/>
          </p:nvSpPr>
          <p:spPr>
            <a:xfrm>
              <a:off x="1218960" y="35661960"/>
              <a:ext cx="38633040" cy="7104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702320"/>
                  <a:tab algn="l" pos="9404280"/>
                </a:tabLst>
              </a:pPr>
              <a:r>
                <a:rPr b="1" lang="en-US" sz="9200" spc="-1" strike="noStrike">
                  <a:solidFill>
                    <a:srgbClr val="000000"/>
                  </a:solidFill>
                  <a:latin typeface="Calibri"/>
                </a:rPr>
                <a:t>Additional file 5 – Interaction network of up-regulated transcripts.</a:t>
              </a:r>
              <a:r>
                <a:rPr b="0" lang="en-US" sz="9200" spc="-1" strike="noStrike">
                  <a:solidFill>
                    <a:srgbClr val="000000"/>
                  </a:solidFill>
                  <a:latin typeface="Calibri"/>
                </a:rPr>
                <a:t> A powerpoint file containing interaction map generated by Pathway Studio (version 7.1).The transcripts up-regulated in present study are highlighted in yellow.</a:t>
              </a:r>
              <a:endParaRPr b="0" lang="en-US" sz="9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702320"/>
                  <a:tab algn="l" pos="9404280"/>
                </a:tabLst>
              </a:pPr>
              <a:endParaRPr b="0" lang="en-US" sz="9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sampa</dc:creator>
  <dc:description/>
  <dc:language>en-US</dc:language>
  <cp:lastModifiedBy>Prof. Sampa Das</cp:lastModifiedBy>
  <dcterms:modified xsi:type="dcterms:W3CDTF">2011-12-19T09:27:01Z</dcterms:modified>
  <cp:revision>2</cp:revision>
  <dc:subject/>
  <dc:title>Slide 1</dc:title>
</cp:coreProperties>
</file>